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05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1191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7513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1156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02517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45051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2968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2914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55307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4885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3005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296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37797E-804C-4A1B-9300-E8BD25F0BB45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75BB38-D501-4074-95FE-E7883D6E3B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66486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2265869" y="222900"/>
            <a:ext cx="4385147" cy="6024609"/>
            <a:chOff x="1371600" y="51479"/>
            <a:chExt cx="4616141" cy="6574886"/>
          </a:xfrm>
        </p:grpSpPr>
        <p:grpSp>
          <p:nvGrpSpPr>
            <p:cNvPr id="26" name="Group 31"/>
            <p:cNvGrpSpPr/>
            <p:nvPr/>
          </p:nvGrpSpPr>
          <p:grpSpPr>
            <a:xfrm>
              <a:off x="1371600" y="2096811"/>
              <a:ext cx="4616141" cy="4529554"/>
              <a:chOff x="3352800" y="838200"/>
              <a:chExt cx="4616141" cy="4529554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3352800" y="838200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IR64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648200" y="838200"/>
                <a:ext cx="3320741" cy="369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i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O. longistaminata  </a:t>
                </a: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(IRGC110404)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267200" y="838200"/>
                <a:ext cx="3048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×</a:t>
                </a:r>
              </a:p>
            </p:txBody>
          </p:sp>
          <p:cxnSp>
            <p:nvCxnSpPr>
              <p:cNvPr id="32" name="Straight Arrow Connector 31"/>
              <p:cNvCxnSpPr/>
              <p:nvPr/>
            </p:nvCxnSpPr>
            <p:spPr>
              <a:xfrm>
                <a:off x="4419600" y="1219200"/>
                <a:ext cx="0" cy="457200"/>
              </a:xfrm>
              <a:prstGeom prst="straightConnector1">
                <a:avLst/>
              </a:prstGeom>
              <a:ln w="38100">
                <a:solidFill>
                  <a:srgbClr val="00206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/>
              <p:cNvSpPr txBox="1"/>
              <p:nvPr/>
            </p:nvSpPr>
            <p:spPr>
              <a:xfrm>
                <a:off x="4267200" y="1676400"/>
                <a:ext cx="457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F</a:t>
                </a:r>
                <a:r>
                  <a:rPr lang="en-PH" sz="1600" b="1" baseline="-25000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cxnSp>
            <p:nvCxnSpPr>
              <p:cNvPr id="34" name="Straight Arrow Connector 33"/>
              <p:cNvCxnSpPr/>
              <p:nvPr/>
            </p:nvCxnSpPr>
            <p:spPr>
              <a:xfrm>
                <a:off x="4953000" y="2133600"/>
                <a:ext cx="0" cy="457200"/>
              </a:xfrm>
              <a:prstGeom prst="straightConnector1">
                <a:avLst/>
              </a:prstGeom>
              <a:ln w="38100">
                <a:solidFill>
                  <a:srgbClr val="00206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5181600" y="1676400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IR64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724400" y="1676400"/>
                <a:ext cx="3048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×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4419600" y="2667000"/>
                <a:ext cx="9906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BC</a:t>
                </a:r>
                <a:r>
                  <a:rPr lang="en-PH" sz="1600" b="1" baseline="-25000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1</a:t>
                </a: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F</a:t>
                </a:r>
                <a:r>
                  <a:rPr lang="en-PH" sz="1600" b="1" baseline="-25000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5791200" y="2667000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IR64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5334000" y="2667000"/>
                <a:ext cx="3048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×</a:t>
                </a:r>
              </a:p>
            </p:txBody>
          </p:sp>
          <p:cxnSp>
            <p:nvCxnSpPr>
              <p:cNvPr id="40" name="Straight Arrow Connector 39"/>
              <p:cNvCxnSpPr/>
              <p:nvPr/>
            </p:nvCxnSpPr>
            <p:spPr>
              <a:xfrm>
                <a:off x="5562600" y="3048000"/>
                <a:ext cx="0" cy="457200"/>
              </a:xfrm>
              <a:prstGeom prst="straightConnector1">
                <a:avLst/>
              </a:prstGeom>
              <a:ln w="38100">
                <a:solidFill>
                  <a:srgbClr val="00206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5105400" y="3657600"/>
                <a:ext cx="9906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BC</a:t>
                </a:r>
                <a:r>
                  <a:rPr lang="en-PH" sz="1600" b="1" baseline="-25000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F</a:t>
                </a:r>
                <a:r>
                  <a:rPr lang="en-PH" sz="1600" b="1" baseline="-25000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cxnSp>
            <p:nvCxnSpPr>
              <p:cNvPr id="42" name="Straight Arrow Connector 41"/>
              <p:cNvCxnSpPr/>
              <p:nvPr/>
            </p:nvCxnSpPr>
            <p:spPr>
              <a:xfrm>
                <a:off x="5562600" y="4114800"/>
                <a:ext cx="0" cy="457200"/>
              </a:xfrm>
              <a:prstGeom prst="straightConnector1">
                <a:avLst/>
              </a:prstGeom>
              <a:ln w="38100">
                <a:solidFill>
                  <a:srgbClr val="00206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5105400" y="4648200"/>
                <a:ext cx="9906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BC</a:t>
                </a:r>
                <a:r>
                  <a:rPr lang="en-PH" sz="1600" b="1" baseline="-25000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n-PH" sz="1600" b="1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F</a:t>
                </a:r>
                <a:r>
                  <a:rPr lang="en-PH" sz="1600" b="1" baseline="-25000" dirty="0">
                    <a:latin typeface="Times New Roman" panose="02020603050405020304" pitchFamily="18" charset="0"/>
                    <a:ea typeface="Verdana" panose="020B0604030504040204" pitchFamily="34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5257800" y="5029200"/>
                <a:ext cx="12573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PH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57)</a:t>
                </a:r>
                <a:endParaRPr lang="en-PH" sz="1600" b="1" dirty="0">
                  <a:latin typeface="Times New Roman" panose="02020603050405020304" pitchFamily="18" charset="0"/>
                  <a:ea typeface="Verdana" panose="020B0604030504040204" pitchFamily="34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7" name="Picture 26" descr="97B-OL_F1.jpg"/>
            <p:cNvPicPr>
              <a:picLocks noChangeAspect="1"/>
            </p:cNvPicPr>
            <p:nvPr/>
          </p:nvPicPr>
          <p:blipFill>
            <a:blip r:embed="rId2" cstate="print">
              <a:lum bright="40000" contrast="40000"/>
            </a:blip>
            <a:srcRect l="53333" r="13333"/>
            <a:stretch>
              <a:fillRect/>
            </a:stretch>
          </p:blipFill>
          <p:spPr>
            <a:xfrm>
              <a:off x="3429000" y="51479"/>
              <a:ext cx="471329" cy="2107812"/>
            </a:xfrm>
            <a:prstGeom prst="rect">
              <a:avLst/>
            </a:prstGeom>
          </p:spPr>
        </p:pic>
        <p:pic>
          <p:nvPicPr>
            <p:cNvPr id="28" name="Picture 2" descr="F:\Photographs_97B_25B patents with F1s_Joie\25March2013\IMG_0242 - Copy.JPG"/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l="7031" t="59007" r="62500"/>
            <a:stretch>
              <a:fillRect/>
            </a:stretch>
          </p:blipFill>
          <p:spPr bwMode="auto">
            <a:xfrm>
              <a:off x="1456000" y="563687"/>
              <a:ext cx="753800" cy="1521249"/>
            </a:xfrm>
            <a:prstGeom prst="rect">
              <a:avLst/>
            </a:prstGeom>
            <a:noFill/>
          </p:spPr>
        </p:pic>
      </p:grpSp>
      <p:sp>
        <p:nvSpPr>
          <p:cNvPr id="45" name="Rectangle 44"/>
          <p:cNvSpPr/>
          <p:nvPr/>
        </p:nvSpPr>
        <p:spPr>
          <a:xfrm>
            <a:off x="324553" y="6499570"/>
            <a:ext cx="8652505" cy="254913"/>
          </a:xfrm>
          <a:prstGeom prst="rect">
            <a:avLst/>
          </a:prstGeom>
        </p:spPr>
        <p:txBody>
          <a:bodyPr wrap="square" lIns="69568" tIns="34784" rIns="69568" bIns="34784">
            <a:spAutoFit/>
          </a:bodyPr>
          <a:lstStyle/>
          <a:p>
            <a:pPr marL="570230" indent="-570230"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:  Figure S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eding scheme depicting the development of mapping population derived from IR64 × OL(IRGC110404)</a:t>
            </a:r>
          </a:p>
        </p:txBody>
      </p:sp>
    </p:spTree>
    <p:extLst>
      <p:ext uri="{BB962C8B-B14F-4D97-AF65-F5344CB8AC3E}">
        <p14:creationId xmlns:p14="http://schemas.microsoft.com/office/powerpoint/2010/main" val="2004597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30:34Z</dcterms:created>
  <dcterms:modified xsi:type="dcterms:W3CDTF">2021-09-02T09:30:47Z</dcterms:modified>
</cp:coreProperties>
</file>